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94660"/>
  </p:normalViewPr>
  <p:slideViewPr>
    <p:cSldViewPr snapToGrid="0">
      <p:cViewPr>
        <p:scale>
          <a:sx n="60" d="100"/>
          <a:sy n="60" d="100"/>
        </p:scale>
        <p:origin x="1140" y="2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D38739A-0805-AE06-B08C-3A8FF74BB611}"/>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37864E67-3EB2-C94A-2D29-5AD9781BE32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BA6CDB39-4DC8-8F65-1A9A-E114582EDFB9}"/>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5" name="Segnaposto piè di pagina 4">
            <a:extLst>
              <a:ext uri="{FF2B5EF4-FFF2-40B4-BE49-F238E27FC236}">
                <a16:creationId xmlns:a16="http://schemas.microsoft.com/office/drawing/2014/main" id="{B4EB6517-16C2-0F12-A8D9-059ABB37ECD4}"/>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80D0539C-8BAA-D080-5DAE-03CC29273889}"/>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16159762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A575044-CAD7-CB82-F6C2-B42FC52DEB57}"/>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031C8619-9303-0F6F-BCD1-7D06E11EB604}"/>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4759938D-BAF6-1937-7040-AF488DD77D7F}"/>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5" name="Segnaposto piè di pagina 4">
            <a:extLst>
              <a:ext uri="{FF2B5EF4-FFF2-40B4-BE49-F238E27FC236}">
                <a16:creationId xmlns:a16="http://schemas.microsoft.com/office/drawing/2014/main" id="{A7D1D1D5-7EFC-2996-B379-987595850F50}"/>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D3D9CDA-F785-CB5F-A3C3-4F19F1E6422D}"/>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3665055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7996BB46-72B4-1C4D-5EAE-EA2D234D1D53}"/>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D1D29E35-ED23-86F7-5CE3-9C554C694FF0}"/>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DD663820-EC09-9AAA-4E69-1702FEC569D5}"/>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5" name="Segnaposto piè di pagina 4">
            <a:extLst>
              <a:ext uri="{FF2B5EF4-FFF2-40B4-BE49-F238E27FC236}">
                <a16:creationId xmlns:a16="http://schemas.microsoft.com/office/drawing/2014/main" id="{7D2869F9-A231-5D25-5108-92DD51738ED7}"/>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CF0D29B-48BA-9AC4-B4B2-1EA601A6F91D}"/>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14619364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5B97448-C143-C17E-E79B-BF889A77D28B}"/>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695DCCFC-E632-99B2-EB3B-1948B4E0CD67}"/>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EEB2CF3C-E741-2AAF-7DED-BAD112026B28}"/>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5" name="Segnaposto piè di pagina 4">
            <a:extLst>
              <a:ext uri="{FF2B5EF4-FFF2-40B4-BE49-F238E27FC236}">
                <a16:creationId xmlns:a16="http://schemas.microsoft.com/office/drawing/2014/main" id="{6041929D-8D04-A815-2A06-EB6B2A2975DD}"/>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8FD9097C-3A4C-4BB8-CE63-96F68F1571CF}"/>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25803306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812DB43-AD14-9296-788A-55A3F4B9354B}"/>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4055E3C9-DB78-5AD2-22C5-C5EF0991489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A04A2ADB-DC61-A11C-2122-0670D410C68D}"/>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5" name="Segnaposto piè di pagina 4">
            <a:extLst>
              <a:ext uri="{FF2B5EF4-FFF2-40B4-BE49-F238E27FC236}">
                <a16:creationId xmlns:a16="http://schemas.microsoft.com/office/drawing/2014/main" id="{7F01F7A6-19B6-DAC1-020D-82E89CD390A7}"/>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7BF4EFDE-0C21-09C3-DB25-77AEF8E95331}"/>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8208802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93425FAC-BAF3-AE61-9629-799F6F4D2195}"/>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CA653C7A-A354-EFA3-C580-CFEA1559B8BE}"/>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19C8128E-BA51-E68F-2E5E-8F0FF5A7FBD5}"/>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DA5C4428-76C9-A866-11CF-21B60D70AA0F}"/>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6" name="Segnaposto piè di pagina 5">
            <a:extLst>
              <a:ext uri="{FF2B5EF4-FFF2-40B4-BE49-F238E27FC236}">
                <a16:creationId xmlns:a16="http://schemas.microsoft.com/office/drawing/2014/main" id="{130EC173-6DC1-C915-657A-F4126DC51EB7}"/>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4E765D9D-23C8-D258-276A-5E8296E7A52E}"/>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20250589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5620D30-8933-1B58-D443-A7D396E1DD2B}"/>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BAB5AEB6-BEE7-BA4E-EB1B-F0C6A06CDF2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14E1AB5F-2F2F-13DB-0139-00458C4F919E}"/>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8F853BA7-3A93-5AA5-75B3-C72A127C68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7D870310-18B2-F0E5-1232-E76B1A48F9E8}"/>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26F2F0BA-2678-A83D-1D69-C8B702CE6C3F}"/>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8" name="Segnaposto piè di pagina 7">
            <a:extLst>
              <a:ext uri="{FF2B5EF4-FFF2-40B4-BE49-F238E27FC236}">
                <a16:creationId xmlns:a16="http://schemas.microsoft.com/office/drawing/2014/main" id="{08EC8F9E-04BC-45A1-63EA-2A17EC3C808F}"/>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70C0021E-BFB0-6992-A4DF-C4B1662D8B43}"/>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2322444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2D842C2-EECC-6E52-0D87-BEBA1F795282}"/>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7013C46E-D1B9-A055-E962-D67814E13525}"/>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4" name="Segnaposto piè di pagina 3">
            <a:extLst>
              <a:ext uri="{FF2B5EF4-FFF2-40B4-BE49-F238E27FC236}">
                <a16:creationId xmlns:a16="http://schemas.microsoft.com/office/drawing/2014/main" id="{9A065620-6425-6B89-CC65-808F7E59F058}"/>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1767BEE0-DE9D-53FC-049E-F8ABDC065BC6}"/>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2064632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0CCAF8DF-A6FA-3A26-8C00-71F9C4100295}"/>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3" name="Segnaposto piè di pagina 2">
            <a:extLst>
              <a:ext uri="{FF2B5EF4-FFF2-40B4-BE49-F238E27FC236}">
                <a16:creationId xmlns:a16="http://schemas.microsoft.com/office/drawing/2014/main" id="{8E2234C3-3557-DB87-3561-5B0AAB4EF0C4}"/>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2D57C550-6005-73AD-EA57-865FC7ABEFD9}"/>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1041059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98F14510-89B8-C109-C30B-5B97D50AEC7B}"/>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D1E2C656-E1BD-EE7D-39E6-BE5A3B17A3C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2BFB4E48-0ACF-6A7F-88B0-1EE926F980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45992893-2D2F-FC02-05CD-EA70A4717D5D}"/>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6" name="Segnaposto piè di pagina 5">
            <a:extLst>
              <a:ext uri="{FF2B5EF4-FFF2-40B4-BE49-F238E27FC236}">
                <a16:creationId xmlns:a16="http://schemas.microsoft.com/office/drawing/2014/main" id="{FADBA65A-D95B-7144-31A9-80DA9EA3EE1D}"/>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C9516B86-D5B2-E897-8BBF-6488E4AF92B8}"/>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7372130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3B15C06B-32AD-B6EA-7B56-BFD69DCC8606}"/>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FF97B81E-A446-4A71-C52F-F71EE2249A6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12EEA5BB-B475-62E5-7746-B4E11AF3DE3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765E464B-A7F6-626B-570E-E08679E50BD4}"/>
              </a:ext>
            </a:extLst>
          </p:cNvPr>
          <p:cNvSpPr>
            <a:spLocks noGrp="1"/>
          </p:cNvSpPr>
          <p:nvPr>
            <p:ph type="dt" sz="half" idx="10"/>
          </p:nvPr>
        </p:nvSpPr>
        <p:spPr/>
        <p:txBody>
          <a:bodyPr/>
          <a:lstStyle/>
          <a:p>
            <a:fld id="{B9626715-3CFB-48E3-AF28-3C7673EFCFA1}" type="datetimeFigureOut">
              <a:rPr lang="it-IT" smtClean="0"/>
              <a:t>14/06/2024</a:t>
            </a:fld>
            <a:endParaRPr lang="it-IT"/>
          </a:p>
        </p:txBody>
      </p:sp>
      <p:sp>
        <p:nvSpPr>
          <p:cNvPr id="6" name="Segnaposto piè di pagina 5">
            <a:extLst>
              <a:ext uri="{FF2B5EF4-FFF2-40B4-BE49-F238E27FC236}">
                <a16:creationId xmlns:a16="http://schemas.microsoft.com/office/drawing/2014/main" id="{8CE9CC8E-E95D-DF5D-12EF-3FA03A863E2E}"/>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80633C13-5B22-B8A2-C85D-43D27A1612F5}"/>
              </a:ext>
            </a:extLst>
          </p:cNvPr>
          <p:cNvSpPr>
            <a:spLocks noGrp="1"/>
          </p:cNvSpPr>
          <p:nvPr>
            <p:ph type="sldNum" sz="quarter" idx="12"/>
          </p:nvPr>
        </p:nvSpPr>
        <p:spPr/>
        <p:txBody>
          <a:bodyPr/>
          <a:lstStyle/>
          <a:p>
            <a:fld id="{05ECEBA6-A7F3-4A85-81E2-AF6AB9CB713E}" type="slidenum">
              <a:rPr lang="it-IT" smtClean="0"/>
              <a:t>‹N›</a:t>
            </a:fld>
            <a:endParaRPr lang="it-IT"/>
          </a:p>
        </p:txBody>
      </p:sp>
    </p:spTree>
    <p:extLst>
      <p:ext uri="{BB962C8B-B14F-4D97-AF65-F5344CB8AC3E}">
        <p14:creationId xmlns:p14="http://schemas.microsoft.com/office/powerpoint/2010/main" val="8943643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693C15B8-BC66-AE10-F123-6146D674DAD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29E8BA62-4385-54E8-392E-D1E67EE97A1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6053C5CB-7D74-D8A2-A325-0C4D1F157FA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626715-3CFB-48E3-AF28-3C7673EFCFA1}" type="datetimeFigureOut">
              <a:rPr lang="it-IT" smtClean="0"/>
              <a:t>14/06/2024</a:t>
            </a:fld>
            <a:endParaRPr lang="it-IT"/>
          </a:p>
        </p:txBody>
      </p:sp>
      <p:sp>
        <p:nvSpPr>
          <p:cNvPr id="5" name="Segnaposto piè di pagina 4">
            <a:extLst>
              <a:ext uri="{FF2B5EF4-FFF2-40B4-BE49-F238E27FC236}">
                <a16:creationId xmlns:a16="http://schemas.microsoft.com/office/drawing/2014/main" id="{B66CED3B-FC0A-C9DF-CDC6-6F07C31FFA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EF912C83-9DFD-CB56-5BF3-82CF9AE7559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5ECEBA6-A7F3-4A85-81E2-AF6AB9CB713E}" type="slidenum">
              <a:rPr lang="it-IT" smtClean="0"/>
              <a:t>‹N›</a:t>
            </a:fld>
            <a:endParaRPr lang="it-IT"/>
          </a:p>
        </p:txBody>
      </p:sp>
    </p:spTree>
    <p:extLst>
      <p:ext uri="{BB962C8B-B14F-4D97-AF65-F5344CB8AC3E}">
        <p14:creationId xmlns:p14="http://schemas.microsoft.com/office/powerpoint/2010/main" val="39554671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uppo 8">
            <a:extLst>
              <a:ext uri="{FF2B5EF4-FFF2-40B4-BE49-F238E27FC236}">
                <a16:creationId xmlns:a16="http://schemas.microsoft.com/office/drawing/2014/main" id="{06BF9E66-BA7E-D0FF-ACB6-D0359CA20786}"/>
              </a:ext>
            </a:extLst>
          </p:cNvPr>
          <p:cNvGrpSpPr/>
          <p:nvPr/>
        </p:nvGrpSpPr>
        <p:grpSpPr>
          <a:xfrm>
            <a:off x="1624513" y="274626"/>
            <a:ext cx="8553157" cy="6433786"/>
            <a:chOff x="1505243" y="576776"/>
            <a:chExt cx="8904849" cy="6433786"/>
          </a:xfrm>
        </p:grpSpPr>
        <p:pic>
          <p:nvPicPr>
            <p:cNvPr id="4" name="Immagine 3">
              <a:extLst>
                <a:ext uri="{FF2B5EF4-FFF2-40B4-BE49-F238E27FC236}">
                  <a16:creationId xmlns:a16="http://schemas.microsoft.com/office/drawing/2014/main" id="{83C4E234-0F32-FDD6-EE81-54EC7BC72DA6}"/>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505243" y="590844"/>
              <a:ext cx="8904849" cy="5034723"/>
            </a:xfrm>
            <a:prstGeom prst="rect">
              <a:avLst/>
            </a:prstGeom>
            <a:noFill/>
          </p:spPr>
        </p:pic>
        <p:sp>
          <p:nvSpPr>
            <p:cNvPr id="7" name="CasellaDiTesto 6">
              <a:extLst>
                <a:ext uri="{FF2B5EF4-FFF2-40B4-BE49-F238E27FC236}">
                  <a16:creationId xmlns:a16="http://schemas.microsoft.com/office/drawing/2014/main" id="{CE34E87A-D8B1-BF12-F59C-3C2D08215535}"/>
                </a:ext>
              </a:extLst>
            </p:cNvPr>
            <p:cNvSpPr txBox="1"/>
            <p:nvPr/>
          </p:nvSpPr>
          <p:spPr>
            <a:xfrm>
              <a:off x="1505243" y="5625567"/>
              <a:ext cx="8904849" cy="1384995"/>
            </a:xfrm>
            <a:prstGeom prst="rect">
              <a:avLst/>
            </a:prstGeom>
            <a:noFill/>
          </p:spPr>
          <p:txBody>
            <a:bodyPr wrap="square" rtlCol="0">
              <a:spAutoFit/>
            </a:bodyPr>
            <a:lstStyle/>
            <a:p>
              <a:pPr algn="just"/>
              <a:r>
                <a:rPr lang="en-GB" sz="12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igure S1. </a:t>
              </a:r>
              <a:r>
                <a:rPr lang="en-GB"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alculated</a:t>
              </a:r>
              <a:r>
                <a:rPr lang="en-GB" sz="12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n-GB"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probabilities of germination in the four plots for ungerminated viable seeds of </a:t>
              </a:r>
              <a:r>
                <a:rPr lang="en-GB" sz="1200" i="1" dirty="0">
                  <a:solidFill>
                    <a:srgbClr val="000000"/>
                  </a:solidFill>
                  <a:effectLst/>
                  <a:highlight>
                    <a:srgbClr val="FFFFFF"/>
                  </a:highlight>
                  <a:latin typeface="Palatino Linotype" panose="02040502050505030304" pitchFamily="18" charset="0"/>
                  <a:ea typeface="Times New Roman" panose="02020603050405020304" pitchFamily="18" charset="0"/>
                  <a:cs typeface="Times New Roman" panose="02020603050405020304" pitchFamily="18" charset="0"/>
                </a:rPr>
                <a:t>Dianthus pavonius</a:t>
              </a:r>
              <a:r>
                <a:rPr lang="en-GB"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per year and under natural field conditions. </a:t>
              </a:r>
              <a:r>
                <a:rPr lang="it-IT"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Probability of germination was calculated using the additional proportion germinated in a given year relative to the prior year, divided by the proportion of seeds in the prior year that had not germinated.  Note that samples assessed in each year were independent replicate sets of seeds with the potential for sampling error, and in Plot C – year 3, the lower proportion of seeds germinated in the year 3 samples relative to year 2 (see main manuscript Figure 2) results in a negative germination probability being calculated as variation in the estimate due to error variance even though this outcome is not biologically possible.  </a:t>
              </a:r>
            </a:p>
          </p:txBody>
        </p:sp>
        <p:sp>
          <p:nvSpPr>
            <p:cNvPr id="2" name="CasellaDiTesto 1">
              <a:extLst>
                <a:ext uri="{FF2B5EF4-FFF2-40B4-BE49-F238E27FC236}">
                  <a16:creationId xmlns:a16="http://schemas.microsoft.com/office/drawing/2014/main" id="{1C195905-C682-76DC-BB77-B52CED66CD18}"/>
                </a:ext>
              </a:extLst>
            </p:cNvPr>
            <p:cNvSpPr txBox="1"/>
            <p:nvPr/>
          </p:nvSpPr>
          <p:spPr>
            <a:xfrm>
              <a:off x="3038620" y="576776"/>
              <a:ext cx="281353" cy="369332"/>
            </a:xfrm>
            <a:prstGeom prst="rect">
              <a:avLst/>
            </a:prstGeom>
            <a:solidFill>
              <a:schemeClr val="bg1"/>
            </a:solidFill>
          </p:spPr>
          <p:txBody>
            <a:bodyPr wrap="square" rtlCol="0">
              <a:spAutoFit/>
            </a:bodyPr>
            <a:lstStyle/>
            <a:p>
              <a:r>
                <a:rPr lang="it-IT" dirty="0"/>
                <a:t>A</a:t>
              </a:r>
            </a:p>
          </p:txBody>
        </p:sp>
        <p:sp>
          <p:nvSpPr>
            <p:cNvPr id="3" name="CasellaDiTesto 2">
              <a:extLst>
                <a:ext uri="{FF2B5EF4-FFF2-40B4-BE49-F238E27FC236}">
                  <a16:creationId xmlns:a16="http://schemas.microsoft.com/office/drawing/2014/main" id="{4E298547-F0AE-8DAF-26D6-ACBA8B903800}"/>
                </a:ext>
              </a:extLst>
            </p:cNvPr>
            <p:cNvSpPr txBox="1"/>
            <p:nvPr/>
          </p:nvSpPr>
          <p:spPr>
            <a:xfrm>
              <a:off x="7495734" y="576776"/>
              <a:ext cx="281353" cy="369332"/>
            </a:xfrm>
            <a:prstGeom prst="rect">
              <a:avLst/>
            </a:prstGeom>
            <a:solidFill>
              <a:schemeClr val="bg1"/>
            </a:solidFill>
          </p:spPr>
          <p:txBody>
            <a:bodyPr wrap="square" rtlCol="0">
              <a:spAutoFit/>
            </a:bodyPr>
            <a:lstStyle/>
            <a:p>
              <a:r>
                <a:rPr lang="it-IT" dirty="0"/>
                <a:t>B</a:t>
              </a:r>
            </a:p>
          </p:txBody>
        </p:sp>
        <p:sp>
          <p:nvSpPr>
            <p:cNvPr id="5" name="CasellaDiTesto 4">
              <a:extLst>
                <a:ext uri="{FF2B5EF4-FFF2-40B4-BE49-F238E27FC236}">
                  <a16:creationId xmlns:a16="http://schemas.microsoft.com/office/drawing/2014/main" id="{629BE92C-8EB9-C1FA-C19E-E71C2DFCA8A2}"/>
                </a:ext>
              </a:extLst>
            </p:cNvPr>
            <p:cNvSpPr txBox="1"/>
            <p:nvPr/>
          </p:nvSpPr>
          <p:spPr>
            <a:xfrm>
              <a:off x="3009326" y="3115940"/>
              <a:ext cx="281353" cy="369332"/>
            </a:xfrm>
            <a:prstGeom prst="rect">
              <a:avLst/>
            </a:prstGeom>
            <a:solidFill>
              <a:schemeClr val="bg1"/>
            </a:solidFill>
          </p:spPr>
          <p:txBody>
            <a:bodyPr wrap="square" rtlCol="0">
              <a:spAutoFit/>
            </a:bodyPr>
            <a:lstStyle/>
            <a:p>
              <a:r>
                <a:rPr lang="it-IT" dirty="0"/>
                <a:t>C</a:t>
              </a:r>
            </a:p>
          </p:txBody>
        </p:sp>
        <p:sp>
          <p:nvSpPr>
            <p:cNvPr id="6" name="CasellaDiTesto 5">
              <a:extLst>
                <a:ext uri="{FF2B5EF4-FFF2-40B4-BE49-F238E27FC236}">
                  <a16:creationId xmlns:a16="http://schemas.microsoft.com/office/drawing/2014/main" id="{B267DDEC-4FB4-BAC1-6118-B3E2C4AD6F67}"/>
                </a:ext>
              </a:extLst>
            </p:cNvPr>
            <p:cNvSpPr txBox="1"/>
            <p:nvPr/>
          </p:nvSpPr>
          <p:spPr>
            <a:xfrm>
              <a:off x="7495733" y="3115940"/>
              <a:ext cx="281353" cy="369332"/>
            </a:xfrm>
            <a:prstGeom prst="rect">
              <a:avLst/>
            </a:prstGeom>
            <a:solidFill>
              <a:schemeClr val="bg1"/>
            </a:solidFill>
          </p:spPr>
          <p:txBody>
            <a:bodyPr wrap="square" rtlCol="0">
              <a:spAutoFit/>
            </a:bodyPr>
            <a:lstStyle/>
            <a:p>
              <a:r>
                <a:rPr lang="it-IT" dirty="0"/>
                <a:t>D</a:t>
              </a:r>
            </a:p>
          </p:txBody>
        </p:sp>
      </p:grpSp>
    </p:spTree>
    <p:extLst>
      <p:ext uri="{BB962C8B-B14F-4D97-AF65-F5344CB8AC3E}">
        <p14:creationId xmlns:p14="http://schemas.microsoft.com/office/powerpoint/2010/main" val="1911563578"/>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4</TotalTime>
  <Words>141</Words>
  <Application>Microsoft Office PowerPoint</Application>
  <PresentationFormat>Widescreen</PresentationFormat>
  <Paragraphs>5</Paragraphs>
  <Slides>1</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Palatino Linotype</vt:lpstr>
      <vt:lpstr>Tema di Office</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Valentina Carasso</dc:creator>
  <cp:lastModifiedBy>Utente</cp:lastModifiedBy>
  <cp:revision>7</cp:revision>
  <dcterms:created xsi:type="dcterms:W3CDTF">2024-05-21T12:07:02Z</dcterms:created>
  <dcterms:modified xsi:type="dcterms:W3CDTF">2024-06-14T08:44:48Z</dcterms:modified>
</cp:coreProperties>
</file>